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9438" y="217926"/>
            <a:ext cx="5848866" cy="44352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23528" y="4653136"/>
            <a:ext cx="8496944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. S3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Cytological observation of pollen development in autotetraploid rice hybrids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yad stage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etrad stage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Early microspore stage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ddle microspore stage, cell wall formation starts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iddle microspore stage, vacuolization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ate microspore stage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ate microspore stage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arly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icellula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age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iddl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icellula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age.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ddl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icellula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age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k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at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icellula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age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ture pollen stage. Bars 40μm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33438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2</cp:revision>
  <dcterms:modified xsi:type="dcterms:W3CDTF">2017-10-19T07:31:56Z</dcterms:modified>
</cp:coreProperties>
</file>